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jpe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59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75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329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147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232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199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192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589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411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344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274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631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3AED2-203E-4234-B67C-3373C0D91F08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30CA0-2853-4357-BB7C-FB6D799789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795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2.tif"/><Relationship Id="rId7" Type="http://schemas.openxmlformats.org/officeDocument/2006/relationships/image" Target="../media/image5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1179B5C8-1951-4273-9614-294C64687A80}"/>
              </a:ext>
            </a:extLst>
          </p:cNvPr>
          <p:cNvSpPr txBox="1"/>
          <p:nvPr/>
        </p:nvSpPr>
        <p:spPr>
          <a:xfrm>
            <a:off x="4310045" y="4028"/>
            <a:ext cx="342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0FBE91DF-F6FB-404E-AE96-B5DE5FF73AD4}"/>
              </a:ext>
            </a:extLst>
          </p:cNvPr>
          <p:cNvGrpSpPr/>
          <p:nvPr/>
        </p:nvGrpSpPr>
        <p:grpSpPr>
          <a:xfrm>
            <a:off x="1494943" y="10403"/>
            <a:ext cx="5955292" cy="6821245"/>
            <a:chOff x="1494943" y="10403"/>
            <a:chExt cx="5955292" cy="6821245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5CD7E1F0-DE15-4CE5-808E-B04DE8BBB163}"/>
                </a:ext>
              </a:extLst>
            </p:cNvPr>
            <p:cNvGrpSpPr/>
            <p:nvPr/>
          </p:nvGrpSpPr>
          <p:grpSpPr>
            <a:xfrm>
              <a:off x="1517280" y="44891"/>
              <a:ext cx="5800563" cy="6786757"/>
              <a:chOff x="40818" y="17999"/>
              <a:chExt cx="5800563" cy="6786757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99B119E8-9ECD-4C1A-8973-637C9ECFDF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biLevel thresh="75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98" r="27863" b="8398"/>
              <a:stretch/>
            </p:blipFill>
            <p:spPr>
              <a:xfrm>
                <a:off x="282183" y="4534891"/>
                <a:ext cx="2539014" cy="2036200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B6BB8381-0818-479B-90A8-49C57DF04C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biLevel thresh="75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61" r="51150" b="6913"/>
              <a:stretch/>
            </p:blipFill>
            <p:spPr>
              <a:xfrm>
                <a:off x="266331" y="17999"/>
                <a:ext cx="2166152" cy="2036200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6FD67E40-242E-462F-86A3-CEF5ADE5D2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biLevel thresh="75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56" r="30212" b="8866"/>
              <a:stretch/>
            </p:blipFill>
            <p:spPr>
              <a:xfrm>
                <a:off x="184531" y="2234475"/>
                <a:ext cx="2636666" cy="2036200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DF0A5E94-CE5A-47A0-AAF1-EF26F4F60C55}"/>
                  </a:ext>
                </a:extLst>
              </p:cNvPr>
              <p:cNvSpPr txBox="1"/>
              <p:nvPr/>
            </p:nvSpPr>
            <p:spPr>
              <a:xfrm rot="16200000">
                <a:off x="-301805" y="897599"/>
                <a:ext cx="9622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roteins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AEDDD861-F1FD-42B1-91E3-CF845830F07F}"/>
                  </a:ext>
                </a:extLst>
              </p:cNvPr>
              <p:cNvSpPr txBox="1"/>
              <p:nvPr/>
            </p:nvSpPr>
            <p:spPr>
              <a:xfrm rot="16200000">
                <a:off x="-291285" y="3104473"/>
                <a:ext cx="9622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roteins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E28FB0DC-1411-4C0A-A3E5-E0062C09E338}"/>
                  </a:ext>
                </a:extLst>
              </p:cNvPr>
              <p:cNvSpPr txBox="1"/>
              <p:nvPr/>
            </p:nvSpPr>
            <p:spPr>
              <a:xfrm rot="16200000">
                <a:off x="-161827" y="5432271"/>
                <a:ext cx="7530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roteins</a:t>
                </a:r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A8824F8F-B94B-4302-8406-0AC140C4731A}"/>
                  </a:ext>
                </a:extLst>
              </p:cNvPr>
              <p:cNvSpPr/>
              <p:nvPr/>
            </p:nvSpPr>
            <p:spPr>
              <a:xfrm>
                <a:off x="643925" y="1970259"/>
                <a:ext cx="141096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olecular weights</a:t>
                </a: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523F9A9F-B734-4713-8FB8-D0B327FAE270}"/>
                  </a:ext>
                </a:extLst>
              </p:cNvPr>
              <p:cNvSpPr/>
              <p:nvPr/>
            </p:nvSpPr>
            <p:spPr>
              <a:xfrm>
                <a:off x="703113" y="4270675"/>
                <a:ext cx="130837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nique peptides </a:t>
                </a:r>
                <a:endParaRPr lang="en-US" sz="1200" dirty="0"/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51DD73DE-00AF-41DD-8EF5-2FC1E915DA5C}"/>
                  </a:ext>
                </a:extLst>
              </p:cNvPr>
              <p:cNvSpPr/>
              <p:nvPr/>
            </p:nvSpPr>
            <p:spPr>
              <a:xfrm>
                <a:off x="720869" y="6527757"/>
                <a:ext cx="15215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equence coverage</a:t>
                </a:r>
                <a:endParaRPr lang="en-US" sz="1200" dirty="0"/>
              </a:p>
            </p:txBody>
          </p:sp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0AF5A766-4B0F-4A88-B3F1-3F5848F356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biLevel thresh="75000"/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62" r="50978" b="8190"/>
              <a:stretch/>
            </p:blipFill>
            <p:spPr>
              <a:xfrm>
                <a:off x="3046710" y="17999"/>
                <a:ext cx="2293111" cy="1970324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3938AA51-2B31-46F9-8CDE-1ADE6B2DAB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biLevel thresh="75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40" t="17548" r="41648" b="7287"/>
              <a:stretch/>
            </p:blipFill>
            <p:spPr>
              <a:xfrm>
                <a:off x="3110582" y="2310245"/>
                <a:ext cx="2730799" cy="2036201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6110FD96-3052-4798-9CFE-FE4336A458A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biLevel thresh="75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41" r="16495" b="8942"/>
              <a:stretch/>
            </p:blipFill>
            <p:spPr>
              <a:xfrm>
                <a:off x="3275735" y="4501953"/>
                <a:ext cx="2565646" cy="2036201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560B32A0-20F5-4337-B1B4-A41C59B93E9A}"/>
                  </a:ext>
                </a:extLst>
              </p:cNvPr>
              <p:cNvSpPr txBox="1"/>
              <p:nvPr/>
            </p:nvSpPr>
            <p:spPr>
              <a:xfrm rot="16200000">
                <a:off x="2490960" y="741637"/>
                <a:ext cx="9622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roteins</a:t>
                </a: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D24C421C-CCEC-4A11-967C-D23B3E0557E7}"/>
                  </a:ext>
                </a:extLst>
              </p:cNvPr>
              <p:cNvSpPr/>
              <p:nvPr/>
            </p:nvSpPr>
            <p:spPr>
              <a:xfrm>
                <a:off x="3487783" y="1955492"/>
                <a:ext cx="141096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olecular weights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4672A15-3BEE-4624-B3A8-25252EEC5682}"/>
                  </a:ext>
                </a:extLst>
              </p:cNvPr>
              <p:cNvSpPr txBox="1"/>
              <p:nvPr/>
            </p:nvSpPr>
            <p:spPr>
              <a:xfrm rot="16200000">
                <a:off x="2611632" y="3010839"/>
                <a:ext cx="9622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roteins</a:t>
                </a: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4BC4AC7D-3B61-456E-9EBA-99076CDBC0A6}"/>
                  </a:ext>
                </a:extLst>
              </p:cNvPr>
              <p:cNvSpPr/>
              <p:nvPr/>
            </p:nvSpPr>
            <p:spPr>
              <a:xfrm>
                <a:off x="3938876" y="4285700"/>
                <a:ext cx="130837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nique peptides </a:t>
                </a:r>
                <a:endParaRPr lang="en-US" sz="1200" dirty="0"/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F0C668CE-1F6E-433C-B54A-14D7C59C3C10}"/>
                  </a:ext>
                </a:extLst>
              </p:cNvPr>
              <p:cNvSpPr/>
              <p:nvPr/>
            </p:nvSpPr>
            <p:spPr>
              <a:xfrm>
                <a:off x="3757576" y="6527756"/>
                <a:ext cx="15215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equence coverage</a:t>
                </a:r>
                <a:endParaRPr lang="en-US" sz="1200" dirty="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7E01C9DE-E1F5-4A56-8180-B30B8264F1AF}"/>
                  </a:ext>
                </a:extLst>
              </p:cNvPr>
              <p:cNvSpPr txBox="1"/>
              <p:nvPr/>
            </p:nvSpPr>
            <p:spPr>
              <a:xfrm rot="16200000">
                <a:off x="2808678" y="5381554"/>
                <a:ext cx="7530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roteins</a:t>
                </a:r>
              </a:p>
            </p:txBody>
          </p:sp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5139704-97C9-4EEF-9885-2D2AF23EE580}"/>
                </a:ext>
              </a:extLst>
            </p:cNvPr>
            <p:cNvSpPr txBox="1"/>
            <p:nvPr/>
          </p:nvSpPr>
          <p:spPr>
            <a:xfrm>
              <a:off x="1494943" y="10403"/>
              <a:ext cx="3427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CA5CC5D-8D5F-42F1-A8FB-4AB389738C44}"/>
                </a:ext>
              </a:extLst>
            </p:cNvPr>
            <p:cNvSpPr txBox="1"/>
            <p:nvPr/>
          </p:nvSpPr>
          <p:spPr>
            <a:xfrm>
              <a:off x="2179575" y="131209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5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A93117F-6CD6-4A4D-92ED-9D97984A7E54}"/>
                </a:ext>
              </a:extLst>
            </p:cNvPr>
            <p:cNvSpPr txBox="1"/>
            <p:nvPr/>
          </p:nvSpPr>
          <p:spPr>
            <a:xfrm>
              <a:off x="2528635" y="1244361"/>
              <a:ext cx="6627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-10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F3465D8-1EE2-4AC0-B3AF-8350A79D5D0F}"/>
                </a:ext>
              </a:extLst>
            </p:cNvPr>
            <p:cNvSpPr txBox="1"/>
            <p:nvPr/>
          </p:nvSpPr>
          <p:spPr>
            <a:xfrm>
              <a:off x="2889130" y="1689364"/>
              <a:ext cx="6627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-15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2AA4F2B-B07C-4F81-93D9-E89FA7CEEDA5}"/>
                </a:ext>
              </a:extLst>
            </p:cNvPr>
            <p:cNvSpPr txBox="1"/>
            <p:nvPr/>
          </p:nvSpPr>
          <p:spPr>
            <a:xfrm>
              <a:off x="3316011" y="1748988"/>
              <a:ext cx="6627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-20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E45E154-C0A2-47B3-AF08-E64F7399D700}"/>
                </a:ext>
              </a:extLst>
            </p:cNvPr>
            <p:cNvSpPr txBox="1"/>
            <p:nvPr/>
          </p:nvSpPr>
          <p:spPr>
            <a:xfrm>
              <a:off x="5065400" y="62657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5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BA0A310-AD82-402B-88F5-1F6B762B3279}"/>
                </a:ext>
              </a:extLst>
            </p:cNvPr>
            <p:cNvSpPr txBox="1"/>
            <p:nvPr/>
          </p:nvSpPr>
          <p:spPr>
            <a:xfrm>
              <a:off x="5415338" y="1226299"/>
              <a:ext cx="6627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-10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FB2261B-EA87-4001-9AFF-7ED60773BCDF}"/>
                </a:ext>
              </a:extLst>
            </p:cNvPr>
            <p:cNvSpPr txBox="1"/>
            <p:nvPr/>
          </p:nvSpPr>
          <p:spPr>
            <a:xfrm>
              <a:off x="5763482" y="1658409"/>
              <a:ext cx="6627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-15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EC0A756-B383-4205-A91E-FD3FC25DEBAD}"/>
                </a:ext>
              </a:extLst>
            </p:cNvPr>
            <p:cNvSpPr txBox="1"/>
            <p:nvPr/>
          </p:nvSpPr>
          <p:spPr>
            <a:xfrm>
              <a:off x="6218614" y="1703766"/>
              <a:ext cx="6627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-20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B5BBBC6-BC46-4544-8AA7-6852643F2BC8}"/>
                </a:ext>
              </a:extLst>
            </p:cNvPr>
            <p:cNvSpPr txBox="1"/>
            <p:nvPr/>
          </p:nvSpPr>
          <p:spPr>
            <a:xfrm>
              <a:off x="2179575" y="2283756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5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D1576E7-D4BC-4BD7-924C-26191F1AC2F3}"/>
                </a:ext>
              </a:extLst>
            </p:cNvPr>
            <p:cNvSpPr txBox="1"/>
            <p:nvPr/>
          </p:nvSpPr>
          <p:spPr>
            <a:xfrm>
              <a:off x="2602998" y="3418575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-1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AE87429-70B5-4C42-AD63-A13DCECE00EF}"/>
                </a:ext>
              </a:extLst>
            </p:cNvPr>
            <p:cNvSpPr txBox="1"/>
            <p:nvPr/>
          </p:nvSpPr>
          <p:spPr>
            <a:xfrm>
              <a:off x="3001384" y="3845072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-15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EFAB5A3-2F9C-4ECC-8883-845C494C9A2F}"/>
                </a:ext>
              </a:extLst>
            </p:cNvPr>
            <p:cNvSpPr txBox="1"/>
            <p:nvPr/>
          </p:nvSpPr>
          <p:spPr>
            <a:xfrm>
              <a:off x="3422383" y="3996653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-2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715FBB2-9714-4CB8-8383-E516319E1CE3}"/>
                </a:ext>
              </a:extLst>
            </p:cNvPr>
            <p:cNvSpPr txBox="1"/>
            <p:nvPr/>
          </p:nvSpPr>
          <p:spPr>
            <a:xfrm>
              <a:off x="3860021" y="4005650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-25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635FD09-D9C6-481F-9C66-5D60E0C6DB3C}"/>
                </a:ext>
              </a:extLst>
            </p:cNvPr>
            <p:cNvSpPr txBox="1"/>
            <p:nvPr/>
          </p:nvSpPr>
          <p:spPr>
            <a:xfrm>
              <a:off x="5151488" y="2246078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FA90559-9782-4E52-8A3C-70BE2282803D}"/>
                </a:ext>
              </a:extLst>
            </p:cNvPr>
            <p:cNvSpPr txBox="1"/>
            <p:nvPr/>
          </p:nvSpPr>
          <p:spPr>
            <a:xfrm>
              <a:off x="5563534" y="3118801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-10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78477D2-7AB9-4209-B00D-B69AC38404C4}"/>
                </a:ext>
              </a:extLst>
            </p:cNvPr>
            <p:cNvSpPr txBox="1"/>
            <p:nvPr/>
          </p:nvSpPr>
          <p:spPr>
            <a:xfrm>
              <a:off x="5975333" y="3674090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-15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4B679F6-D499-477B-867F-18262D3776F6}"/>
                </a:ext>
              </a:extLst>
            </p:cNvPr>
            <p:cNvSpPr txBox="1"/>
            <p:nvPr/>
          </p:nvSpPr>
          <p:spPr>
            <a:xfrm>
              <a:off x="6421953" y="3860429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-2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3363476-C5D7-4ED3-B739-5E21B6FB1A83}"/>
                </a:ext>
              </a:extLst>
            </p:cNvPr>
            <p:cNvSpPr txBox="1"/>
            <p:nvPr/>
          </p:nvSpPr>
          <p:spPr>
            <a:xfrm>
              <a:off x="6855810" y="4024514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-2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5B0DDB8-F3BB-49CA-8D6D-5D812A36DDB0}"/>
                </a:ext>
              </a:extLst>
            </p:cNvPr>
            <p:cNvSpPr txBox="1"/>
            <p:nvPr/>
          </p:nvSpPr>
          <p:spPr>
            <a:xfrm>
              <a:off x="2103609" y="4780066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10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D327FA8-F17B-45CF-B423-7542F34146CC}"/>
                </a:ext>
              </a:extLst>
            </p:cNvPr>
            <p:cNvSpPr txBox="1"/>
            <p:nvPr/>
          </p:nvSpPr>
          <p:spPr>
            <a:xfrm>
              <a:off x="2431245" y="5490528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-20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023B04F-5DCE-4FF1-9C18-34850726CDB9}"/>
                </a:ext>
              </a:extLst>
            </p:cNvPr>
            <p:cNvSpPr txBox="1"/>
            <p:nvPr/>
          </p:nvSpPr>
          <p:spPr>
            <a:xfrm>
              <a:off x="2817184" y="5915089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-30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0934A078-8A82-4DDA-B72D-9E66E3EBA80A}"/>
                </a:ext>
              </a:extLst>
            </p:cNvPr>
            <p:cNvSpPr txBox="1"/>
            <p:nvPr/>
          </p:nvSpPr>
          <p:spPr>
            <a:xfrm>
              <a:off x="3171947" y="5997037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-40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404BE74E-99C6-4A86-983C-6B1AF831395B}"/>
                </a:ext>
              </a:extLst>
            </p:cNvPr>
            <p:cNvSpPr txBox="1"/>
            <p:nvPr/>
          </p:nvSpPr>
          <p:spPr>
            <a:xfrm>
              <a:off x="3544708" y="5995546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-50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4DB5573-08CB-47E4-B279-FF6545F94466}"/>
                </a:ext>
              </a:extLst>
            </p:cNvPr>
            <p:cNvSpPr txBox="1"/>
            <p:nvPr/>
          </p:nvSpPr>
          <p:spPr>
            <a:xfrm>
              <a:off x="3908945" y="6211474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-60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F463E2D-134F-4992-B68E-AF107C1ABB87}"/>
                </a:ext>
              </a:extLst>
            </p:cNvPr>
            <p:cNvSpPr txBox="1"/>
            <p:nvPr/>
          </p:nvSpPr>
          <p:spPr>
            <a:xfrm>
              <a:off x="5011197" y="4624909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10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51CC5A2-782A-438D-B9FB-DB3353AFB400}"/>
                </a:ext>
              </a:extLst>
            </p:cNvPr>
            <p:cNvSpPr txBox="1"/>
            <p:nvPr/>
          </p:nvSpPr>
          <p:spPr>
            <a:xfrm>
              <a:off x="5260142" y="4838468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-2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94F4E39A-752E-4BCE-9C8A-FA45CD0EA2A3}"/>
                </a:ext>
              </a:extLst>
            </p:cNvPr>
            <p:cNvSpPr txBox="1"/>
            <p:nvPr/>
          </p:nvSpPr>
          <p:spPr>
            <a:xfrm>
              <a:off x="5548458" y="5490527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-30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F38B10E-8C6C-42CC-B21D-9D0E7620A3A7}"/>
                </a:ext>
              </a:extLst>
            </p:cNvPr>
            <p:cNvSpPr txBox="1"/>
            <p:nvPr/>
          </p:nvSpPr>
          <p:spPr>
            <a:xfrm>
              <a:off x="5830030" y="5623827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-4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B4404732-C53D-439D-901D-A161CB4F0E9B}"/>
                </a:ext>
              </a:extLst>
            </p:cNvPr>
            <p:cNvSpPr txBox="1"/>
            <p:nvPr/>
          </p:nvSpPr>
          <p:spPr>
            <a:xfrm>
              <a:off x="6111602" y="5810096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-50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2F0C02D-6CAA-4DD1-9703-1F6574119B89}"/>
                </a:ext>
              </a:extLst>
            </p:cNvPr>
            <p:cNvSpPr txBox="1"/>
            <p:nvPr/>
          </p:nvSpPr>
          <p:spPr>
            <a:xfrm>
              <a:off x="6430001" y="5851084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-6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2A4849A9-FAE4-4674-916F-A403CF3C1233}"/>
                </a:ext>
              </a:extLst>
            </p:cNvPr>
            <p:cNvSpPr txBox="1"/>
            <p:nvPr/>
          </p:nvSpPr>
          <p:spPr>
            <a:xfrm>
              <a:off x="6665234" y="6124597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-70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0F7E9BFA-8A22-44F2-93EB-9B11B5E3E1BB}"/>
                </a:ext>
              </a:extLst>
            </p:cNvPr>
            <p:cNvSpPr txBox="1"/>
            <p:nvPr/>
          </p:nvSpPr>
          <p:spPr>
            <a:xfrm>
              <a:off x="6963673" y="6215095"/>
              <a:ext cx="4865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-80</a:t>
              </a:r>
            </a:p>
          </p:txBody>
        </p:sp>
      </p:grpSp>
      <p:sp>
        <p:nvSpPr>
          <p:cNvPr id="57" name="Rectangle 56">
            <a:extLst>
              <a:ext uri="{FF2B5EF4-FFF2-40B4-BE49-F238E27FC236}">
                <a16:creationId xmlns:a16="http://schemas.microsoft.com/office/drawing/2014/main" id="{17583D46-36FA-4715-B215-07C3BAFAB0C2}"/>
              </a:ext>
            </a:extLst>
          </p:cNvPr>
          <p:cNvSpPr/>
          <p:nvPr/>
        </p:nvSpPr>
        <p:spPr>
          <a:xfrm>
            <a:off x="6007339" y="43331"/>
            <a:ext cx="319155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</a:rPr>
              <a:t>Supplementary </a:t>
            </a:r>
            <a:r>
              <a:rPr lang="en-US" sz="1200" b="1">
                <a:latin typeface="Arial" panose="020B0604020202020204" pitchFamily="34" charset="0"/>
              </a:rPr>
              <a:t>Figure 2</a:t>
            </a:r>
            <a:r>
              <a:rPr lang="en-US" sz="1200">
                <a:latin typeface="Arial" panose="020B0604020202020204" pitchFamily="34" charset="0"/>
              </a:rPr>
              <a:t>: </a:t>
            </a:r>
            <a:r>
              <a:rPr lang="en-US" sz="1200" dirty="0">
                <a:latin typeface="Arial" panose="020B0604020202020204" pitchFamily="34" charset="0"/>
              </a:rPr>
              <a:t>Distribution of proteins molecular weights, unique peptides, and sequence coverage of proteins identified in DC (A) and RC (B) form. </a:t>
            </a:r>
          </a:p>
        </p:txBody>
      </p:sp>
    </p:spTree>
    <p:extLst>
      <p:ext uri="{BB962C8B-B14F-4D97-AF65-F5344CB8AC3E}">
        <p14:creationId xmlns:p14="http://schemas.microsoft.com/office/powerpoint/2010/main" val="1646042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83</Words>
  <Application>Microsoft Office PowerPoint</Application>
  <PresentationFormat>On-screen Show (4:3)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dramouli Kondethimmanahalli</dc:creator>
  <cp:lastModifiedBy>CHANDRAMOULI KONDETHIMMANAHALLIHANUMANTHARAYAPPA</cp:lastModifiedBy>
  <cp:revision>2</cp:revision>
  <dcterms:created xsi:type="dcterms:W3CDTF">2020-10-30T15:50:14Z</dcterms:created>
  <dcterms:modified xsi:type="dcterms:W3CDTF">2024-09-14T20:09:59Z</dcterms:modified>
</cp:coreProperties>
</file>